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68" autoAdjust="0"/>
    <p:restoredTop sz="94660"/>
  </p:normalViewPr>
  <p:slideViewPr>
    <p:cSldViewPr snapToGrid="0">
      <p:cViewPr varScale="1">
        <p:scale>
          <a:sx n="92" d="100"/>
          <a:sy n="92" d="100"/>
        </p:scale>
        <p:origin x="-128" y="-4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47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507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77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819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537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35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148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90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239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271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396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8D59C-28B1-46B7-B248-1CF916501FEE}" type="datetimeFigureOut">
              <a:rPr lang="en-US" smtClean="0"/>
              <a:t>18/07/3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9667E-0642-4368-99E8-1EBB17D4E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23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36625" y="6030564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2: Histogram of chemicals differentiating the </a:t>
            </a:r>
            <a:r>
              <a:rPr lang="en-US" dirty="0" err="1" smtClean="0"/>
              <a:t>ethanolic</a:t>
            </a:r>
            <a:r>
              <a:rPr lang="en-US" dirty="0" smtClean="0"/>
              <a:t> extract from the water extract linked to the S-plot presented in Fig 5 </a:t>
            </a:r>
            <a:endParaRPr lang="en-US" i="1" dirty="0"/>
          </a:p>
        </p:txBody>
      </p:sp>
      <p:pic>
        <p:nvPicPr>
          <p:cNvPr id="5" name="Picture 4" descr="C:\Users\SYNAPT~1\AppData\Local\Temp\_SP_a808492786803a991c9ada8ed85f6b6c\untitled685_files\img69F1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26" t="36717" b="36029"/>
          <a:stretch/>
        </p:blipFill>
        <p:spPr bwMode="auto">
          <a:xfrm>
            <a:off x="7565944" y="1947012"/>
            <a:ext cx="3305597" cy="1936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SYNAPT~1\AppData\Local\Temp\_SP_a808492786803a991c9ada8ed85f6b6c\untitled685_files\img69F1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38" b="10420"/>
          <a:stretch/>
        </p:blipFill>
        <p:spPr bwMode="auto">
          <a:xfrm>
            <a:off x="2020376" y="1034153"/>
            <a:ext cx="5815668" cy="36805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14410" y="276115"/>
            <a:ext cx="3326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Fil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3888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9</TotalTime>
  <Words>27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</dc:creator>
  <cp:lastModifiedBy>NP Makunga</cp:lastModifiedBy>
  <cp:revision>6</cp:revision>
  <dcterms:created xsi:type="dcterms:W3CDTF">2018-03-01T22:38:55Z</dcterms:created>
  <dcterms:modified xsi:type="dcterms:W3CDTF">2018-07-31T19:37:39Z</dcterms:modified>
</cp:coreProperties>
</file>